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D67792-4988-41BD-9FDF-43A712A83A1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BD2B45-1321-44B0-8199-D47D6A46E51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7E4709-C0CB-4B70-A89F-9DA4C0087B1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7E6CD7-5817-4CE3-8D75-B70CCCED693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93B33F-9493-40F8-A124-50CA5D99735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B43DD3-55AC-45FF-90B5-766721441AF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28F4E3-729F-487A-A2FC-266FB1A1B7B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6D3010-83AC-4912-81AB-4FAD6EC6647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24236F-4A72-41C8-99C8-441B4848921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C14C89-FC2B-4BF1-AD32-11E63D66B24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AA3AE7-AC9D-4D20-A59E-B66E6EF896F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F65EAE-F990-4C75-889C-EC1AEC9A3F1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4140171-EC81-437F-A136-B41A68A83A22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1042920" y="1447920"/>
          <a:ext cx="7345440" cy="1730160"/>
        </p:xfrm>
        <a:graphic>
          <a:graphicData uri="http://schemas.openxmlformats.org/drawingml/2006/table">
            <a:tbl>
              <a:tblPr/>
              <a:tblGrid>
                <a:gridCol w="2737080"/>
                <a:gridCol w="1584000"/>
                <a:gridCol w="1656000"/>
                <a:gridCol w="1368360"/>
              </a:tblGrid>
              <a:tr h="511200">
                <a:tc rowSpan="2">
                  <a:txBody>
                    <a:bodyPr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nl-NL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Viru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gridSpan="3">
                  <a:txBody>
                    <a:bodyPr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nl-NL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(P)LD</a:t>
                      </a:r>
                      <a:r>
                        <a:rPr b="0" lang="nl-NL" sz="1400" spc="-1" strike="noStrike" baseline="-25000">
                          <a:solidFill>
                            <a:srgbClr val="000000"/>
                          </a:solidFill>
                          <a:latin typeface="Calibri"/>
                        </a:rPr>
                        <a:t>50</a:t>
                      </a:r>
                      <a:r>
                        <a:rPr b="0" lang="nl-NL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(PFU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3045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nl-NL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Intra cerebral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Intra muscular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Intra peritoneal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04920">
                <a:tc>
                  <a:txBody>
                    <a:bodyPr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nl-NL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Mahoney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x10</a:t>
                      </a:r>
                      <a:r>
                        <a:rPr b="0" lang="en-US" sz="1400" spc="-1" strike="noStrike" baseline="30000">
                          <a:solidFill>
                            <a:srgbClr val="000000"/>
                          </a:solidFill>
                          <a:latin typeface="Calibri"/>
                        </a:rPr>
                        <a:t>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.58x10</a:t>
                      </a:r>
                      <a:r>
                        <a:rPr b="0" lang="en-US" sz="1400" spc="-1" strike="noStrike" baseline="30000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x10</a:t>
                      </a:r>
                      <a:r>
                        <a:rPr b="0" lang="en-US" sz="1400" spc="-1" strike="noStrike" baseline="30000">
                          <a:solidFill>
                            <a:srgbClr val="000000"/>
                          </a:solidFill>
                          <a:latin typeface="Calibri"/>
                        </a:rPr>
                        <a:t>5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04920">
                <a:tc>
                  <a:txBody>
                    <a:bodyPr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nl-NL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abin 1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&gt;2x10</a:t>
                      </a:r>
                      <a:r>
                        <a:rPr b="0" lang="en-US" sz="1400" spc="-1" strike="noStrike" baseline="30000">
                          <a:solidFill>
                            <a:srgbClr val="000000"/>
                          </a:solidFill>
                          <a:latin typeface="Calibri"/>
                        </a:rPr>
                        <a:t>7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nl-NL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b="0" lang="nl-NL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d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nl-NL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d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04560">
                <a:tc>
                  <a:txBody>
                    <a:bodyPr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nl-NL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AVA backbon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&gt;9x10</a:t>
                      </a:r>
                      <a:r>
                        <a:rPr b="0" lang="en-US" sz="1400" spc="-1" strike="noStrike" baseline="30000">
                          <a:solidFill>
                            <a:srgbClr val="000000"/>
                          </a:solidFill>
                          <a:latin typeface="Calibri"/>
                        </a:rPr>
                        <a:t>7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&gt;10</a:t>
                      </a:r>
                      <a:r>
                        <a:rPr b="0" lang="en-US" sz="1400" spc="-1" strike="noStrike" baseline="30000">
                          <a:solidFill>
                            <a:srgbClr val="000000"/>
                          </a:solidFill>
                          <a:latin typeface="Calibri"/>
                        </a:rPr>
                        <a:t>8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&gt;10</a:t>
                      </a:r>
                      <a:r>
                        <a:rPr b="0" lang="en-US" sz="1400" spc="-1" strike="noStrike" baseline="30000">
                          <a:solidFill>
                            <a:srgbClr val="000000"/>
                          </a:solidFill>
                          <a:latin typeface="Calibri"/>
                        </a:rPr>
                        <a:t>8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01-13T15:35:05Z</dcterms:created>
  <dc:creator>Sanders, Barbara [CRXNL]</dc:creator>
  <dc:description/>
  <dc:language>en-US</dc:language>
  <cp:lastModifiedBy>Sanders, Barbara [CRXNL]</cp:lastModifiedBy>
  <dcterms:modified xsi:type="dcterms:W3CDTF">2016-01-13T17:09:10Z</dcterms:modified>
  <cp:revision>9</cp:revision>
  <dc:subject/>
  <dc:title>PowerPoint Presentation</dc:title>
</cp:coreProperties>
</file>